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B1955-33C2-4A4F-AE92-916C52A507D8}" type="datetimeFigureOut">
              <a:rPr lang="en-US" smtClean="0"/>
              <a:t>3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044E9-D22C-42C4-9B0E-99BF7A427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817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B1955-33C2-4A4F-AE92-916C52A507D8}" type="datetimeFigureOut">
              <a:rPr lang="en-US" smtClean="0"/>
              <a:t>3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044E9-D22C-42C4-9B0E-99BF7A427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394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B1955-33C2-4A4F-AE92-916C52A507D8}" type="datetimeFigureOut">
              <a:rPr lang="en-US" smtClean="0"/>
              <a:t>3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044E9-D22C-42C4-9B0E-99BF7A427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852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B1955-33C2-4A4F-AE92-916C52A507D8}" type="datetimeFigureOut">
              <a:rPr lang="en-US" smtClean="0"/>
              <a:t>3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044E9-D22C-42C4-9B0E-99BF7A427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089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B1955-33C2-4A4F-AE92-916C52A507D8}" type="datetimeFigureOut">
              <a:rPr lang="en-US" smtClean="0"/>
              <a:t>3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044E9-D22C-42C4-9B0E-99BF7A427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36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B1955-33C2-4A4F-AE92-916C52A507D8}" type="datetimeFigureOut">
              <a:rPr lang="en-US" smtClean="0"/>
              <a:t>3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044E9-D22C-42C4-9B0E-99BF7A427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0134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B1955-33C2-4A4F-AE92-916C52A507D8}" type="datetimeFigureOut">
              <a:rPr lang="en-US" smtClean="0"/>
              <a:t>3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044E9-D22C-42C4-9B0E-99BF7A427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146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B1955-33C2-4A4F-AE92-916C52A507D8}" type="datetimeFigureOut">
              <a:rPr lang="en-US" smtClean="0"/>
              <a:t>3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044E9-D22C-42C4-9B0E-99BF7A427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188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B1955-33C2-4A4F-AE92-916C52A507D8}" type="datetimeFigureOut">
              <a:rPr lang="en-US" smtClean="0"/>
              <a:t>3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044E9-D22C-42C4-9B0E-99BF7A427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249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B1955-33C2-4A4F-AE92-916C52A507D8}" type="datetimeFigureOut">
              <a:rPr lang="en-US" smtClean="0"/>
              <a:t>3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044E9-D22C-42C4-9B0E-99BF7A427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422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B1955-33C2-4A4F-AE92-916C52A507D8}" type="datetimeFigureOut">
              <a:rPr lang="en-US" smtClean="0"/>
              <a:t>3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044E9-D22C-42C4-9B0E-99BF7A427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278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0B1955-33C2-4A4F-AE92-916C52A507D8}" type="datetimeFigureOut">
              <a:rPr lang="en-US" smtClean="0"/>
              <a:t>3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3044E9-D22C-42C4-9B0E-99BF7A427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685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4009246"/>
              </p:ext>
            </p:extLst>
          </p:nvPr>
        </p:nvGraphicFramePr>
        <p:xfrm>
          <a:off x="3631845" y="732647"/>
          <a:ext cx="5409126" cy="1469640"/>
        </p:xfrm>
        <a:graphic>
          <a:graphicData uri="http://schemas.openxmlformats.org/drawingml/2006/table">
            <a:tbl>
              <a:tblPr firstRow="1" firstCol="1" bandRow="1"/>
              <a:tblGrid>
                <a:gridCol w="822069"/>
                <a:gridCol w="1168444"/>
                <a:gridCol w="1265307"/>
                <a:gridCol w="1076653"/>
                <a:gridCol w="1076653"/>
              </a:tblGrid>
              <a:tr h="445346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 b="1" dirty="0" smtClean="0">
                          <a:effectLst/>
                          <a:latin typeface="Times New Roman" panose="02020603050405020304" pitchFamily="18" charset="0"/>
                          <a:ea typeface="MS Mincho"/>
                          <a:cs typeface="Arial" panose="020B0604020202020204" pitchFamily="34" charset="0"/>
                        </a:rPr>
                        <a:t>Sample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MS Mincho"/>
                          <a:cs typeface="Arial" panose="020B0604020202020204" pitchFamily="34" charset="0"/>
                        </a:rPr>
                        <a:t>A260/A28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MS Mincho"/>
                          <a:cs typeface="Arial" panose="020B0604020202020204" pitchFamily="34" charset="0"/>
                        </a:rPr>
                        <a:t>A260/A23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 b="1" dirty="0" smtClean="0">
                          <a:effectLst/>
                          <a:latin typeface="Times New Roman" panose="02020603050405020304" pitchFamily="18" charset="0"/>
                          <a:ea typeface="MS Mincho"/>
                          <a:cs typeface="Arial" panose="020B0604020202020204" pitchFamily="34" charset="0"/>
                        </a:rPr>
                        <a:t>Concentration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MS Mincho"/>
                          <a:cs typeface="Arial" panose="020B0604020202020204" pitchFamily="34" charset="0"/>
                        </a:rPr>
                        <a:t>(ng/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MS Mincho"/>
                          <a:cs typeface="Times New Roman" panose="02020603050405020304" pitchFamily="18" charset="0"/>
                        </a:rPr>
                        <a:t>µ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MS Mincho"/>
                          <a:cs typeface="Arial" panose="020B0604020202020204" pitchFamily="34" charset="0"/>
                        </a:rPr>
                        <a:t>L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 b="1" dirty="0" smtClean="0">
                          <a:effectLst/>
                          <a:latin typeface="Times New Roman" panose="02020603050405020304" pitchFamily="18" charset="0"/>
                          <a:ea typeface="MS Mincho"/>
                          <a:cs typeface="Arial" panose="020B0604020202020204" pitchFamily="34" charset="0"/>
                        </a:rPr>
                        <a:t>RIN 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7723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 b="0" dirty="0">
                          <a:effectLst/>
                          <a:latin typeface="Times New Roman" panose="02020603050405020304" pitchFamily="18" charset="0"/>
                          <a:ea typeface="MS Mincho"/>
                          <a:cs typeface="Arial" panose="020B0604020202020204" pitchFamily="34" charset="0"/>
                        </a:rPr>
                        <a:t>C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 b="0">
                          <a:effectLst/>
                          <a:latin typeface="Times New Roman" panose="02020603050405020304" pitchFamily="18" charset="0"/>
                          <a:ea typeface="MS Mincho"/>
                          <a:cs typeface="Arial" panose="020B0604020202020204" pitchFamily="34" charset="0"/>
                        </a:rPr>
                        <a:t>2.02</a:t>
                      </a:r>
                      <a:endParaRPr lang="en-US" sz="1000" b="1">
                        <a:effectLst/>
                        <a:latin typeface="Times New Roman" panose="02020603050405020304" pitchFamily="18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 b="0">
                          <a:effectLst/>
                          <a:latin typeface="Times New Roman" panose="02020603050405020304" pitchFamily="18" charset="0"/>
                          <a:ea typeface="MS Mincho"/>
                          <a:cs typeface="Arial" panose="020B0604020202020204" pitchFamily="34" charset="0"/>
                        </a:rPr>
                        <a:t>1.96</a:t>
                      </a:r>
                      <a:endParaRPr lang="en-US" sz="1000" b="1">
                        <a:effectLst/>
                        <a:latin typeface="Times New Roman" panose="02020603050405020304" pitchFamily="18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 b="0">
                          <a:effectLst/>
                          <a:latin typeface="Times New Roman" panose="02020603050405020304" pitchFamily="18" charset="0"/>
                          <a:ea typeface="MS Mincho"/>
                          <a:cs typeface="Arial" panose="020B0604020202020204" pitchFamily="34" charset="0"/>
                        </a:rPr>
                        <a:t>864.9</a:t>
                      </a:r>
                      <a:endParaRPr lang="en-US" sz="1000" b="1">
                        <a:effectLst/>
                        <a:latin typeface="Times New Roman" panose="02020603050405020304" pitchFamily="18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 b="0" dirty="0" smtClean="0">
                          <a:effectLst/>
                          <a:latin typeface="Times New Roman" panose="02020603050405020304" pitchFamily="18" charset="0"/>
                          <a:ea typeface="MS Mincho"/>
                          <a:cs typeface="Arial" panose="020B0604020202020204" pitchFamily="34" charset="0"/>
                        </a:rPr>
                        <a:t>7.6</a:t>
                      </a:r>
                      <a:endParaRPr lang="en-US" sz="1000" b="0" dirty="0">
                        <a:effectLst/>
                        <a:latin typeface="Times New Roman" panose="02020603050405020304" pitchFamily="18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58857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MS Mincho"/>
                        </a:rPr>
                        <a:t>C2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MS Mincho"/>
                        </a:rPr>
                        <a:t>2.0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MS Mincho"/>
                        </a:rPr>
                        <a:t>2.0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MS Mincho"/>
                        </a:rPr>
                        <a:t>2168.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ea typeface="MS Mincho"/>
                        </a:rPr>
                        <a:t>7.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8857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MS Mincho"/>
                        </a:rPr>
                        <a:t>F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MS Mincho"/>
                        </a:rPr>
                        <a:t>2.0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MS Mincho"/>
                        </a:rPr>
                        <a:t>2.14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MS Mincho"/>
                        </a:rPr>
                        <a:t>690.7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ea typeface="MS Mincho"/>
                        </a:rPr>
                        <a:t>7.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8857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MS Mincho"/>
                        </a:rPr>
                        <a:t>F2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MS Mincho"/>
                        </a:rPr>
                        <a:t>2.06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MS Mincho"/>
                        </a:rPr>
                        <a:t>2.09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MS Mincho"/>
                        </a:rPr>
                        <a:t>1860.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ea typeface="MS Mincho"/>
                        </a:rPr>
                        <a:t>7.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6" name="Picture 5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6117" y="2547138"/>
            <a:ext cx="6052429" cy="341578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734875" y="6220496"/>
            <a:ext cx="54606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dditional File 2. RNA quality control for each samp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05256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8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3</cp:revision>
  <dcterms:created xsi:type="dcterms:W3CDTF">2018-03-26T04:29:55Z</dcterms:created>
  <dcterms:modified xsi:type="dcterms:W3CDTF">2018-03-26T04:41:02Z</dcterms:modified>
</cp:coreProperties>
</file>